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" initials="A" lastIdx="1" clrIdx="0">
    <p:extLst>
      <p:ext uri="{19B8F6BF-5375-455C-9EA6-DF929625EA0E}">
        <p15:presenceInfo xmlns:p15="http://schemas.microsoft.com/office/powerpoint/2012/main" userId="Admi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0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65466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8559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22806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99455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45738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29297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52348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66203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80505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2542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257546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Edytuj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CE82A8-2ED0-4BD0-8576-ABBA8208D9C0}" type="datetimeFigureOut">
              <a:rPr lang="pl-PL" smtClean="0"/>
              <a:t>03.04.202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C88804-0DAE-47B1-B5DD-66C612ABD81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91299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5976" y="2208276"/>
            <a:ext cx="6480048" cy="2441448"/>
          </a:xfrm>
          <a:prstGeom prst="rect">
            <a:avLst/>
          </a:prstGeom>
        </p:spPr>
      </p:pic>
      <p:sp>
        <p:nvSpPr>
          <p:cNvPr id="5" name="pole tekstowe 4"/>
          <p:cNvSpPr txBox="1"/>
          <p:nvPr/>
        </p:nvSpPr>
        <p:spPr>
          <a:xfrm>
            <a:off x="106878" y="178130"/>
            <a:ext cx="86448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ing of identified full-leng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Redβ proteins encoded by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bacteria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rmicute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 and their phages. </a:t>
            </a:r>
            <a:endParaRPr lang="pl-PL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nectio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P-value lower and higher than 1E-30 are rendered in gray and light teal, respectively.</a:t>
            </a:r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09533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/>
          <p:cNvSpPr txBox="1"/>
          <p:nvPr/>
        </p:nvSpPr>
        <p:spPr>
          <a:xfrm>
            <a:off x="201168" y="192024"/>
            <a:ext cx="1132027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Sheet S1. SSAP dataset and gene context</a:t>
            </a:r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Sheet S2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Redβ protein subset</a:t>
            </a:r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Sheet S3. Spacer ‘matches’ to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sa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of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rmicute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ges </a:t>
            </a:r>
            <a:endParaRPr lang="pl-PL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Sheet S4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t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i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i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2-EC30 prophage reverse transcriptase (RT) homologs of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rmicut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cteria </a:t>
            </a:r>
            <a:endParaRPr lang="pl-PL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pl-PL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thor Contributions: 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S retrieved all data from public databases and prepared Fig. S1.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prepare</a:t>
            </a:r>
            <a:r>
              <a:rPr lang="pl-PL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excel spread sheets and performed manual inspection of all data contained in the files.</a:t>
            </a:r>
          </a:p>
          <a:p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092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9</TotalTime>
  <Words>132</Words>
  <Application>Microsoft Office PowerPoint</Application>
  <PresentationFormat>Panoramiczny</PresentationFormat>
  <Paragraphs>11</Paragraphs>
  <Slides>2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dmin</dc:creator>
  <cp:lastModifiedBy>A</cp:lastModifiedBy>
  <cp:revision>30</cp:revision>
  <dcterms:created xsi:type="dcterms:W3CDTF">2020-12-15T09:12:07Z</dcterms:created>
  <dcterms:modified xsi:type="dcterms:W3CDTF">2021-04-03T15:18:29Z</dcterms:modified>
</cp:coreProperties>
</file>